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452" y="-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BFD7F-AC12-4A8F-88BC-BC3F87C6C026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B9468-BC42-4550-9971-94814EB314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7774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BFD7F-AC12-4A8F-88BC-BC3F87C6C026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B9468-BC42-4550-9971-94814EB314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97136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BFD7F-AC12-4A8F-88BC-BC3F87C6C026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B9468-BC42-4550-9971-94814EB314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0413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BFD7F-AC12-4A8F-88BC-BC3F87C6C026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B9468-BC42-4550-9971-94814EB314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11700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BFD7F-AC12-4A8F-88BC-BC3F87C6C026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B9468-BC42-4550-9971-94814EB314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69028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BFD7F-AC12-4A8F-88BC-BC3F87C6C026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B9468-BC42-4550-9971-94814EB314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00143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BFD7F-AC12-4A8F-88BC-BC3F87C6C026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B9468-BC42-4550-9971-94814EB314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3844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BFD7F-AC12-4A8F-88BC-BC3F87C6C026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B9468-BC42-4550-9971-94814EB314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2231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BFD7F-AC12-4A8F-88BC-BC3F87C6C026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B9468-BC42-4550-9971-94814EB314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408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BFD7F-AC12-4A8F-88BC-BC3F87C6C026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B9468-BC42-4550-9971-94814EB314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2701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BFD7F-AC12-4A8F-88BC-BC3F87C6C026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B9468-BC42-4550-9971-94814EB314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3477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3BFD7F-AC12-4A8F-88BC-BC3F87C6C026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9B9468-BC42-4550-9971-94814EB314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1554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3546617"/>
              </p:ext>
            </p:extLst>
          </p:nvPr>
        </p:nvGraphicFramePr>
        <p:xfrm>
          <a:off x="107504" y="908720"/>
          <a:ext cx="8784976" cy="4975512"/>
        </p:xfrm>
        <a:graphic>
          <a:graphicData uri="http://schemas.openxmlformats.org/drawingml/2006/table">
            <a:tbl>
              <a:tblPr/>
              <a:tblGrid>
                <a:gridCol w="2188390"/>
                <a:gridCol w="1099431"/>
                <a:gridCol w="1099431"/>
                <a:gridCol w="1099431"/>
                <a:gridCol w="1099431"/>
                <a:gridCol w="1099431"/>
                <a:gridCol w="1099431"/>
              </a:tblGrid>
              <a:tr h="362326">
                <a:tc rowSpan="2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ja-JP" alt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　</a:t>
                      </a: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SU</a:t>
                      </a: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BG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l-GR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α-</a:t>
                      </a:r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GI</a:t>
                      </a: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TZD</a:t>
                      </a: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sz="11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Glinide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DPP-4 inhibitor</a:t>
                      </a: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6232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N=228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N=325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N=203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N=140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N=70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N=307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 gridSpan="7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kumimoji="1" lang="en-GB" altLang="ja-JP" sz="1200" b="1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Use of antihypertensive drugs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 fontAlgn="ctr"/>
                      <a:r>
                        <a:rPr lang="en-US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ARB</a:t>
                      </a: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23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3.9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80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5.4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23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60.6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81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7.9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40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7.1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69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5.0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 fontAlgn="ctr"/>
                      <a:r>
                        <a:rPr lang="en-US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CCB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33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8.3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77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4.5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17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7.6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69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49.3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39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5.7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57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1.1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>
                  <a:txBody>
                    <a:bodyPr/>
                    <a:lstStyle/>
                    <a:p>
                      <a:pPr algn="r" fontAlgn="ctr"/>
                      <a:r>
                        <a:rPr kumimoji="1" lang="en-US" sz="1100" b="1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ACE-I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9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2.7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42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2.9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38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8.7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9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6.4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0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4.3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40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3.0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Diuretic</a:t>
                      </a: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65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8.5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7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7.5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9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9.1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9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3.6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4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34.3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82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6.7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>
                  <a:txBody>
                    <a:bodyPr/>
                    <a:lstStyle/>
                    <a:p>
                      <a:pPr algn="r" fontAlgn="ctr"/>
                      <a:r>
                        <a:rPr lang="el-GR" altLang="ja-JP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Β</a:t>
                      </a:r>
                      <a:r>
                        <a:rPr lang="en-US" altLang="ja-JP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-blocker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88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38.6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92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8.3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99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48.8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43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30.7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5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35.7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27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41.4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>
                  <a:txBody>
                    <a:bodyPr/>
                    <a:lstStyle/>
                    <a:p>
                      <a:pPr algn="r" fontAlgn="ctr"/>
                      <a:r>
                        <a:rPr kumimoji="1" lang="en-US" altLang="ja-JP" sz="1100" b="1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Other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5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6.6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31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9.5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4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1.8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9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6.4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0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4.3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2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7.2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 gridSpan="7"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Use of lipid lowering drug</a:t>
                      </a: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strike="noStrike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strike="noStrike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Statin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47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64.5)</a:t>
                      </a:r>
                      <a:endParaRPr kumimoji="1" lang="en-US" altLang="ja-JP" sz="11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06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63.4)</a:t>
                      </a:r>
                      <a:endParaRPr kumimoji="1" lang="en-US" altLang="ja-JP" sz="11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47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72.4)</a:t>
                      </a:r>
                      <a:endParaRPr kumimoji="1" lang="en-US" altLang="ja-JP" sz="11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96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68.6)</a:t>
                      </a:r>
                      <a:endParaRPr kumimoji="1" lang="en-US" altLang="ja-JP" sz="11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41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58.6)</a:t>
                      </a:r>
                      <a:endParaRPr kumimoji="1" lang="en-US" altLang="ja-JP" sz="11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08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67.8)</a:t>
                      </a:r>
                      <a:endParaRPr kumimoji="1" lang="en-US" altLang="ja-JP" sz="11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Other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42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8.4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73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2.5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44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1.7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6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8.6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3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8.6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60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</a:t>
                      </a:r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9.5</a:t>
                      </a:r>
                      <a:r>
                        <a:rPr kumimoji="1" lang="en-US" altLang="ja-JP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714161" y="6021288"/>
            <a:ext cx="81063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altLang="ja-JP" sz="1100" dirty="0" smtClean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, </a:t>
            </a:r>
            <a:r>
              <a:rPr lang="en-GB" altLang="ja-JP" sz="110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ata </a:t>
            </a:r>
            <a:r>
              <a:rPr lang="en-GB" altLang="ja-JP" sz="110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re n </a:t>
            </a:r>
            <a:r>
              <a:rPr lang="en-GB" altLang="ja-JP" sz="110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%)</a:t>
            </a:r>
            <a:endParaRPr lang="ja-JP" altLang="en-US" sz="1100" dirty="0">
              <a:solidFill>
                <a:prstClr val="black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7308304" y="128489"/>
            <a:ext cx="1704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/>
              <a:t>Additional file</a:t>
            </a:r>
            <a:r>
              <a:rPr kumimoji="1" lang="en-US" altLang="ja-JP" b="1" dirty="0" smtClean="0"/>
              <a:t> </a:t>
            </a:r>
            <a:r>
              <a:rPr lang="en-US" altLang="ja-JP" b="1" dirty="0"/>
              <a:t>2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42600974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32</Words>
  <Application>Microsoft Office PowerPoint</Application>
  <PresentationFormat>画面に合わせる (4:3)</PresentationFormat>
  <Paragraphs>12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邉真紀人</dc:creator>
  <cp:lastModifiedBy>田邉真紀人</cp:lastModifiedBy>
  <cp:revision>1</cp:revision>
  <dcterms:created xsi:type="dcterms:W3CDTF">2015-07-31T17:11:41Z</dcterms:created>
  <dcterms:modified xsi:type="dcterms:W3CDTF">2015-07-31T17:19:37Z</dcterms:modified>
</cp:coreProperties>
</file>